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57" r:id="rId4"/>
    <p:sldId id="260" r:id="rId5"/>
    <p:sldId id="256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5" d="100"/>
          <a:sy n="65" d="100"/>
        </p:scale>
        <p:origin x="110" y="1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A4BCB62-3F1E-EF2C-D552-B99CB2CF6F6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8D759188-5E94-EF5B-B6B9-5ACC09EE6DE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D2FB573-0ACA-2623-3527-3AB922DFB7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D583F-7327-4B3E-8C17-48BC94F1C4B3}" type="datetimeFigureOut">
              <a:rPr lang="zh-CN" altLang="en-US" smtClean="0"/>
              <a:t>2026-03-0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0EFD489-599A-3B95-A964-C4BC4108F8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EBE6373-6C83-3611-9E5E-6E563C2E38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8FB76-6789-490B-857C-B7C26FAD06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90315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D6979C3-FB30-35CC-2423-5B5CB63DAB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A4BE532-691D-373E-7641-DCDE6BD37D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A18E3EC-6227-E4CC-7033-E03FAE6636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D583F-7327-4B3E-8C17-48BC94F1C4B3}" type="datetimeFigureOut">
              <a:rPr lang="zh-CN" altLang="en-US" smtClean="0"/>
              <a:t>2026-03-0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6493C9E-0F77-8FE8-B6C3-15AEAC49B5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AACA481-AC24-FD3A-8160-1A778BA203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8FB76-6789-490B-857C-B7C26FAD06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53882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18EE19C-F723-B752-FBC3-376171D221E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E6FBBED-4334-0633-68C8-BFA31311F0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10D434C-2D96-CE45-2E0A-BEDB2D1595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D583F-7327-4B3E-8C17-48BC94F1C4B3}" type="datetimeFigureOut">
              <a:rPr lang="zh-CN" altLang="en-US" smtClean="0"/>
              <a:t>2026-03-0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A670CBE-7A31-B722-AA27-EA60CE050D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73C681F-B1B1-3112-6D37-70255163C1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8FB76-6789-490B-857C-B7C26FAD06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42463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CC9D59A-A4E0-39A4-9587-3187C4B67F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A60190B-7DBF-AA83-EA90-801E469C8E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D1CD9AD-BFFE-9DCF-AFB7-0AD14C445E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D583F-7327-4B3E-8C17-48BC94F1C4B3}" type="datetimeFigureOut">
              <a:rPr lang="zh-CN" altLang="en-US" smtClean="0"/>
              <a:t>2026-03-0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7F2AD09-0713-3690-8A2A-55CAB5C9CA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1F4A1CB-8C92-1520-B720-4BAC057303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8FB76-6789-490B-857C-B7C26FAD06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32107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5E82BFB-39C8-E0D5-2F14-E969E39FF4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3DB22DC-F55E-7F65-07AB-96B386174E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F42B431-FFD7-1033-E104-1FBED25417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D583F-7327-4B3E-8C17-48BC94F1C4B3}" type="datetimeFigureOut">
              <a:rPr lang="zh-CN" altLang="en-US" smtClean="0"/>
              <a:t>2026-03-0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1D7A3BD-0D30-9953-BDB0-6944A443D8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C3FB659-0F71-9D85-8FDE-39611B0F3A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8FB76-6789-490B-857C-B7C26FAD06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7732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C8CA673-2E88-A2E8-ABC2-1647BD2496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8BFA58B-E26B-A4EE-4608-7EAB6CC8FDF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D6A724B-3C54-DC4C-1D4B-8335B068B1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5D95993-AE1B-87BB-16CF-D45715C7ED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D583F-7327-4B3E-8C17-48BC94F1C4B3}" type="datetimeFigureOut">
              <a:rPr lang="zh-CN" altLang="en-US" smtClean="0"/>
              <a:t>2026-03-0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558D7FA-14EA-ADEF-68FC-4C2492FE3A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68AA6BC-EAB8-1F8F-A76E-AB883F0E53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8FB76-6789-490B-857C-B7C26FAD06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12791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E6962D8-E998-60DF-0982-7C2067EBCE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98349E5-930B-00EB-F411-FE8F8C5A63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393D96B-0AE0-71BE-62B4-CF97B46609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A2EA9C5-8B65-8258-01C9-C0E3B38F792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844B38D-5E02-111A-0DB8-86F5C0BFAC6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7CF5788-23B2-A0E8-3FE7-D4D7021FD8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D583F-7327-4B3E-8C17-48BC94F1C4B3}" type="datetimeFigureOut">
              <a:rPr lang="zh-CN" altLang="en-US" smtClean="0"/>
              <a:t>2026-03-0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3FD57EA-AFD0-2BBA-E4F7-632AA5E5B4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F26106F-884C-3D49-6E8F-45690D4304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8FB76-6789-490B-857C-B7C26FAD06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82826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16E84C3-51CF-470D-1C05-6E6A368552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D47FDBE-BD7F-FB65-990D-3C00C083D3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D583F-7327-4B3E-8C17-48BC94F1C4B3}" type="datetimeFigureOut">
              <a:rPr lang="zh-CN" altLang="en-US" smtClean="0"/>
              <a:t>2026-03-0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6E3C7AC-9F7D-C72C-1B4A-845733C049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D38FB3C-6BAF-A490-C52E-5618B832E4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8FB76-6789-490B-857C-B7C26FAD06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31691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9779846-DF0C-4CD8-28A4-96E3221EC8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D583F-7327-4B3E-8C17-48BC94F1C4B3}" type="datetimeFigureOut">
              <a:rPr lang="zh-CN" altLang="en-US" smtClean="0"/>
              <a:t>2026-03-0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EE8F03D-F11F-3E09-B71A-63AA5408A5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6C56ADE-AE04-055B-E093-40958642AA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8FB76-6789-490B-857C-B7C26FAD06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14808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668F3E4-A348-4F2E-D02E-F47446C755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FDB059B-9974-1583-E5A7-FE518507285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6345E37-AE5A-DD12-431C-529A416985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5371DFD-25FF-B424-0073-D55F720379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D583F-7327-4B3E-8C17-48BC94F1C4B3}" type="datetimeFigureOut">
              <a:rPr lang="zh-CN" altLang="en-US" smtClean="0"/>
              <a:t>2026-03-0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1D3B49E-48EB-2938-4802-5E8674FBD0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FB9BF0D-0042-A8D9-E1BB-F14372FB98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8FB76-6789-490B-857C-B7C26FAD06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17214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BD85554-D6A0-B82D-EAF0-A4D5B1E058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32E526C-79DC-2C89-BA1B-017CBDA388B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0E68586-277F-E2E6-D8BF-E390AC7C93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CA4AEB0-94FD-834A-A8A5-0346A2F372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D583F-7327-4B3E-8C17-48BC94F1C4B3}" type="datetimeFigureOut">
              <a:rPr lang="zh-CN" altLang="en-US" smtClean="0"/>
              <a:t>2026-03-0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DD33D88-0700-4318-EF84-D5ADC0BF79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EC969C4-BAFD-1426-DDFA-2BDBF6863D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28FB76-6789-490B-857C-B7C26FAD06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70999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D884B0E-7BCD-07BE-FAB1-2CD4E801FA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D4C3B24-31D6-5C8D-EB0F-5112835335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15294DB-B066-7A95-C1D3-95ADEF359F7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4D583F-7327-4B3E-8C17-48BC94F1C4B3}" type="datetimeFigureOut">
              <a:rPr lang="zh-CN" altLang="en-US" smtClean="0"/>
              <a:t>2026-03-0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A10277B-C1E1-3B85-56EF-0CA0483D302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F27E544-3E6A-1E77-F91E-0884237F979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28FB76-6789-490B-857C-B7C26FAD06D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96284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8CA1DFD-0CF9-B2B7-FDBE-CB2905F07D9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85A37584-57E4-DD94-6E1D-AF9D54F37B4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385354">
            <a:off x="-1" y="0"/>
            <a:ext cx="8379229" cy="685800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5905E573-5EB1-8F76-7388-6C22B733E649}"/>
              </a:ext>
            </a:extLst>
          </p:cNvPr>
          <p:cNvSpPr txBox="1"/>
          <p:nvPr/>
        </p:nvSpPr>
        <p:spPr>
          <a:xfrm>
            <a:off x="246185" y="246185"/>
            <a:ext cx="96212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α-sub</a:t>
            </a:r>
            <a:endParaRPr lang="zh-CN" altLang="en-US" dirty="0"/>
          </a:p>
        </p:txBody>
      </p:sp>
      <p:sp>
        <p:nvSpPr>
          <p:cNvPr id="6" name="テキスト ボックス 1">
            <a:extLst>
              <a:ext uri="{FF2B5EF4-FFF2-40B4-BE49-F238E27FC236}">
                <a16:creationId xmlns:a16="http://schemas.microsoft.com/office/drawing/2014/main" id="{D41AA4A3-8F0E-AD1F-00B6-F847D2683120}"/>
              </a:ext>
            </a:extLst>
          </p:cNvPr>
          <p:cNvSpPr txBox="1"/>
          <p:nvPr/>
        </p:nvSpPr>
        <p:spPr>
          <a:xfrm>
            <a:off x="-138080" y="6335449"/>
            <a:ext cx="731438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The area enclosed by the red box was cropped and used in the Figure.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D4430E23-5680-F512-29B9-88F7880FBFC9}"/>
              </a:ext>
            </a:extLst>
          </p:cNvPr>
          <p:cNvSpPr txBox="1"/>
          <p:nvPr/>
        </p:nvSpPr>
        <p:spPr>
          <a:xfrm rot="19189580">
            <a:off x="3634600" y="2108667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Youn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BD6A243A-CB83-11D9-BD84-F6D088609504}"/>
              </a:ext>
            </a:extLst>
          </p:cNvPr>
          <p:cNvSpPr txBox="1"/>
          <p:nvPr/>
        </p:nvSpPr>
        <p:spPr>
          <a:xfrm rot="19189580">
            <a:off x="4189293" y="2143310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ge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7CF7E058-D550-ADAF-75E7-BCB3AD720214}"/>
              </a:ext>
            </a:extLst>
          </p:cNvPr>
          <p:cNvCxnSpPr>
            <a:cxnSpLocks/>
          </p:cNvCxnSpPr>
          <p:nvPr/>
        </p:nvCxnSpPr>
        <p:spPr>
          <a:xfrm>
            <a:off x="5011420" y="3995420"/>
            <a:ext cx="990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文本框 9">
            <a:extLst>
              <a:ext uri="{FF2B5EF4-FFF2-40B4-BE49-F238E27FC236}">
                <a16:creationId xmlns:a16="http://schemas.microsoft.com/office/drawing/2014/main" id="{60C619CB-7F2C-69AA-84E7-09E8C9AF4FEA}"/>
              </a:ext>
            </a:extLst>
          </p:cNvPr>
          <p:cNvSpPr txBox="1"/>
          <p:nvPr/>
        </p:nvSpPr>
        <p:spPr>
          <a:xfrm>
            <a:off x="5118687" y="3828366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35</a:t>
            </a:r>
            <a:endParaRPr lang="zh-CN" altLang="en-US" sz="1600" dirty="0"/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64960C92-97A2-E095-FEEA-FE66B5C05B3C}"/>
              </a:ext>
            </a:extLst>
          </p:cNvPr>
          <p:cNvCxnSpPr>
            <a:cxnSpLocks/>
          </p:cNvCxnSpPr>
          <p:nvPr/>
        </p:nvCxnSpPr>
        <p:spPr>
          <a:xfrm>
            <a:off x="5011420" y="3492500"/>
            <a:ext cx="990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6832277B-90A3-74A9-AAF3-B6F5E45965F0}"/>
              </a:ext>
            </a:extLst>
          </p:cNvPr>
          <p:cNvSpPr txBox="1"/>
          <p:nvPr/>
        </p:nvSpPr>
        <p:spPr>
          <a:xfrm>
            <a:off x="5118687" y="3325446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40</a:t>
            </a:r>
            <a:endParaRPr lang="zh-CN" altLang="en-US" sz="1600" dirty="0"/>
          </a:p>
        </p:txBody>
      </p: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D02D5931-86E3-2DD3-71C0-118043F3F6D4}"/>
              </a:ext>
            </a:extLst>
          </p:cNvPr>
          <p:cNvCxnSpPr>
            <a:cxnSpLocks/>
          </p:cNvCxnSpPr>
          <p:nvPr/>
        </p:nvCxnSpPr>
        <p:spPr>
          <a:xfrm>
            <a:off x="5011420" y="3124200"/>
            <a:ext cx="990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7A3C4F6E-1FA9-546B-79A2-FE7D3E290052}"/>
              </a:ext>
            </a:extLst>
          </p:cNvPr>
          <p:cNvSpPr txBox="1"/>
          <p:nvPr/>
        </p:nvSpPr>
        <p:spPr>
          <a:xfrm>
            <a:off x="5118687" y="2957146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50</a:t>
            </a:r>
            <a:endParaRPr lang="zh-CN" altLang="en-US" sz="1600" dirty="0"/>
          </a:p>
        </p:txBody>
      </p: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9A696614-52F0-16BC-A150-1F32ABC0ECE9}"/>
              </a:ext>
            </a:extLst>
          </p:cNvPr>
          <p:cNvCxnSpPr>
            <a:cxnSpLocks/>
          </p:cNvCxnSpPr>
          <p:nvPr/>
        </p:nvCxnSpPr>
        <p:spPr>
          <a:xfrm>
            <a:off x="5011420" y="2672080"/>
            <a:ext cx="990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AACD6D78-0AFB-9DAD-CCB0-191D55FEE856}"/>
              </a:ext>
            </a:extLst>
          </p:cNvPr>
          <p:cNvSpPr txBox="1"/>
          <p:nvPr/>
        </p:nvSpPr>
        <p:spPr>
          <a:xfrm>
            <a:off x="5118687" y="2505026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70</a:t>
            </a:r>
            <a:endParaRPr lang="zh-CN" altLang="en-US" sz="1600" dirty="0"/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A5F5E3D1-F3B0-7C65-1FC9-79C44AF625A9}"/>
              </a:ext>
            </a:extLst>
          </p:cNvPr>
          <p:cNvSpPr/>
          <p:nvPr/>
        </p:nvSpPr>
        <p:spPr>
          <a:xfrm>
            <a:off x="3609341" y="3962400"/>
            <a:ext cx="1206500" cy="3352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32348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811FE32-40B1-C1B3-383B-9423E9D6B54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EAD1B99F-E0B2-670D-9BAB-36AB845A6F6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2542">
            <a:off x="-1" y="0"/>
            <a:ext cx="8379229" cy="685800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3A5B7D4B-0161-DBEA-1234-7FFB898987A3}"/>
              </a:ext>
            </a:extLst>
          </p:cNvPr>
          <p:cNvSpPr txBox="1"/>
          <p:nvPr/>
        </p:nvSpPr>
        <p:spPr>
          <a:xfrm>
            <a:off x="246185" y="246185"/>
            <a:ext cx="122822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PSMA7</a:t>
            </a:r>
            <a:endParaRPr lang="zh-CN" altLang="en-US" dirty="0"/>
          </a:p>
        </p:txBody>
      </p:sp>
      <p:sp>
        <p:nvSpPr>
          <p:cNvPr id="6" name="テキスト ボックス 1">
            <a:extLst>
              <a:ext uri="{FF2B5EF4-FFF2-40B4-BE49-F238E27FC236}">
                <a16:creationId xmlns:a16="http://schemas.microsoft.com/office/drawing/2014/main" id="{4253EAEB-F522-18CA-4F51-704002534520}"/>
              </a:ext>
            </a:extLst>
          </p:cNvPr>
          <p:cNvSpPr txBox="1"/>
          <p:nvPr/>
        </p:nvSpPr>
        <p:spPr>
          <a:xfrm>
            <a:off x="-138080" y="6335449"/>
            <a:ext cx="731438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The area enclosed by the red box was cropped and used in the Figure.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60DC0826-A98C-5454-472C-C67DC4BBBD60}"/>
              </a:ext>
            </a:extLst>
          </p:cNvPr>
          <p:cNvSpPr txBox="1"/>
          <p:nvPr/>
        </p:nvSpPr>
        <p:spPr>
          <a:xfrm rot="19189580">
            <a:off x="3142231" y="2776884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Youn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B95677DB-018F-AC48-71BC-6F677A48733C}"/>
              </a:ext>
            </a:extLst>
          </p:cNvPr>
          <p:cNvSpPr txBox="1"/>
          <p:nvPr/>
        </p:nvSpPr>
        <p:spPr>
          <a:xfrm rot="19189580">
            <a:off x="3696924" y="2811527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ge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681AE3BE-B4C8-15A7-D640-3F1EF27879B0}"/>
              </a:ext>
            </a:extLst>
          </p:cNvPr>
          <p:cNvCxnSpPr>
            <a:cxnSpLocks/>
          </p:cNvCxnSpPr>
          <p:nvPr/>
        </p:nvCxnSpPr>
        <p:spPr>
          <a:xfrm>
            <a:off x="4378374" y="4031762"/>
            <a:ext cx="990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文本框 9">
            <a:extLst>
              <a:ext uri="{FF2B5EF4-FFF2-40B4-BE49-F238E27FC236}">
                <a16:creationId xmlns:a16="http://schemas.microsoft.com/office/drawing/2014/main" id="{F257C8D4-68BE-06DE-23B7-2FD35C2C2F03}"/>
              </a:ext>
            </a:extLst>
          </p:cNvPr>
          <p:cNvSpPr txBox="1"/>
          <p:nvPr/>
        </p:nvSpPr>
        <p:spPr>
          <a:xfrm>
            <a:off x="4485641" y="3864708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25</a:t>
            </a:r>
            <a:endParaRPr lang="zh-CN" altLang="en-US" sz="1600" dirty="0"/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4F0CBA57-8F07-F434-3987-38F8DF60F22A}"/>
              </a:ext>
            </a:extLst>
          </p:cNvPr>
          <p:cNvCxnSpPr>
            <a:cxnSpLocks/>
          </p:cNvCxnSpPr>
          <p:nvPr/>
        </p:nvCxnSpPr>
        <p:spPr>
          <a:xfrm>
            <a:off x="4378374" y="3605042"/>
            <a:ext cx="990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7F5BC26C-2E3B-7B94-B599-89BF5C034001}"/>
              </a:ext>
            </a:extLst>
          </p:cNvPr>
          <p:cNvSpPr txBox="1"/>
          <p:nvPr/>
        </p:nvSpPr>
        <p:spPr>
          <a:xfrm>
            <a:off x="4485641" y="3437988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35</a:t>
            </a:r>
            <a:endParaRPr lang="zh-CN" altLang="en-US" sz="1600" dirty="0"/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205F7FF7-29BC-0BC1-8ED7-924E5E3DB005}"/>
              </a:ext>
            </a:extLst>
          </p:cNvPr>
          <p:cNvSpPr/>
          <p:nvPr/>
        </p:nvSpPr>
        <p:spPr>
          <a:xfrm>
            <a:off x="3169920" y="3672840"/>
            <a:ext cx="1059180" cy="3886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41010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89226D9-651E-9CB1-DE77-0FCBBE9DA3E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A41EFFD8-B953-12C9-5973-255A9F06506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0"/>
            <a:ext cx="8379229" cy="685800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5703D6A8-3187-C2C9-F98D-701ED925657A}"/>
              </a:ext>
            </a:extLst>
          </p:cNvPr>
          <p:cNvSpPr txBox="1"/>
          <p:nvPr/>
        </p:nvSpPr>
        <p:spPr>
          <a:xfrm>
            <a:off x="246185" y="246185"/>
            <a:ext cx="123783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PSMC2</a:t>
            </a:r>
            <a:endParaRPr lang="zh-CN" altLang="en-US" dirty="0"/>
          </a:p>
        </p:txBody>
      </p:sp>
      <p:sp>
        <p:nvSpPr>
          <p:cNvPr id="3" name="テキスト ボックス 1">
            <a:extLst>
              <a:ext uri="{FF2B5EF4-FFF2-40B4-BE49-F238E27FC236}">
                <a16:creationId xmlns:a16="http://schemas.microsoft.com/office/drawing/2014/main" id="{6D04D652-48E5-C684-197B-C46029940BC9}"/>
              </a:ext>
            </a:extLst>
          </p:cNvPr>
          <p:cNvSpPr txBox="1"/>
          <p:nvPr/>
        </p:nvSpPr>
        <p:spPr>
          <a:xfrm>
            <a:off x="-138080" y="6335449"/>
            <a:ext cx="731438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The area enclosed by the red box was cropped and used in the Figure.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9ACDCF2E-D60F-17DB-FDB6-5837A6D9101B}"/>
              </a:ext>
            </a:extLst>
          </p:cNvPr>
          <p:cNvSpPr txBox="1"/>
          <p:nvPr/>
        </p:nvSpPr>
        <p:spPr>
          <a:xfrm rot="19189580">
            <a:off x="3095339" y="2835499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Youn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B221433A-D238-9D25-AC1C-2D417569415B}"/>
              </a:ext>
            </a:extLst>
          </p:cNvPr>
          <p:cNvSpPr txBox="1"/>
          <p:nvPr/>
        </p:nvSpPr>
        <p:spPr>
          <a:xfrm rot="19189580">
            <a:off x="3650032" y="2870142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ge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E9DC4906-6D02-D7B9-640D-47E98DCF6AED}"/>
              </a:ext>
            </a:extLst>
          </p:cNvPr>
          <p:cNvCxnSpPr>
            <a:cxnSpLocks/>
          </p:cNvCxnSpPr>
          <p:nvPr/>
        </p:nvCxnSpPr>
        <p:spPr>
          <a:xfrm>
            <a:off x="4111674" y="3780302"/>
            <a:ext cx="990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文本框 9">
            <a:extLst>
              <a:ext uri="{FF2B5EF4-FFF2-40B4-BE49-F238E27FC236}">
                <a16:creationId xmlns:a16="http://schemas.microsoft.com/office/drawing/2014/main" id="{7D64DC31-C7F0-D317-091F-21C09C1FBB0E}"/>
              </a:ext>
            </a:extLst>
          </p:cNvPr>
          <p:cNvSpPr txBox="1"/>
          <p:nvPr/>
        </p:nvSpPr>
        <p:spPr>
          <a:xfrm>
            <a:off x="4218941" y="3613248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40</a:t>
            </a:r>
            <a:endParaRPr lang="zh-CN" altLang="en-US" sz="1600" dirty="0"/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C0577498-7C77-2CD4-C3CD-9EE6491B0DF5}"/>
              </a:ext>
            </a:extLst>
          </p:cNvPr>
          <p:cNvCxnSpPr>
            <a:cxnSpLocks/>
          </p:cNvCxnSpPr>
          <p:nvPr/>
        </p:nvCxnSpPr>
        <p:spPr>
          <a:xfrm>
            <a:off x="4111674" y="3483122"/>
            <a:ext cx="990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61F270A9-69A3-EBE2-B9B4-8F67EE50BE80}"/>
              </a:ext>
            </a:extLst>
          </p:cNvPr>
          <p:cNvSpPr txBox="1"/>
          <p:nvPr/>
        </p:nvSpPr>
        <p:spPr>
          <a:xfrm>
            <a:off x="4218941" y="3316068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50</a:t>
            </a:r>
            <a:endParaRPr lang="zh-CN" altLang="en-US" sz="1600" dirty="0"/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973146C6-97B3-D355-7620-25A99D801D40}"/>
              </a:ext>
            </a:extLst>
          </p:cNvPr>
          <p:cNvSpPr/>
          <p:nvPr/>
        </p:nvSpPr>
        <p:spPr>
          <a:xfrm>
            <a:off x="3007360" y="3388360"/>
            <a:ext cx="1059180" cy="3886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33439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B359D94-BBD4-5B76-2DD0-75DFA999E0B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F8C3F46D-9F51-F0B8-CD1A-68E6D12045E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28610">
            <a:off x="-1" y="0"/>
            <a:ext cx="8379229" cy="685800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1FEAFC93-DDF0-A059-4598-152238C7A651}"/>
              </a:ext>
            </a:extLst>
          </p:cNvPr>
          <p:cNvSpPr txBox="1"/>
          <p:nvPr/>
        </p:nvSpPr>
        <p:spPr>
          <a:xfrm>
            <a:off x="246185" y="246185"/>
            <a:ext cx="119455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RUFY1</a:t>
            </a:r>
            <a:endParaRPr lang="zh-CN" altLang="en-US" dirty="0"/>
          </a:p>
        </p:txBody>
      </p:sp>
      <p:sp>
        <p:nvSpPr>
          <p:cNvPr id="3" name="テキスト ボックス 1">
            <a:extLst>
              <a:ext uri="{FF2B5EF4-FFF2-40B4-BE49-F238E27FC236}">
                <a16:creationId xmlns:a16="http://schemas.microsoft.com/office/drawing/2014/main" id="{F80A16C6-B327-CB10-51EE-DA51D0AFA7FD}"/>
              </a:ext>
            </a:extLst>
          </p:cNvPr>
          <p:cNvSpPr txBox="1"/>
          <p:nvPr/>
        </p:nvSpPr>
        <p:spPr>
          <a:xfrm>
            <a:off x="-138080" y="6335449"/>
            <a:ext cx="731438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The area enclosed by the red box was cropped and used in the Figure.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F34F8649-DA02-F221-6545-EE329D955A09}"/>
              </a:ext>
            </a:extLst>
          </p:cNvPr>
          <p:cNvSpPr txBox="1"/>
          <p:nvPr/>
        </p:nvSpPr>
        <p:spPr>
          <a:xfrm rot="19189580">
            <a:off x="3517370" y="2331407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Youn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247E808E-3289-71E8-FAB4-9AA8FE4D5960}"/>
              </a:ext>
            </a:extLst>
          </p:cNvPr>
          <p:cNvSpPr txBox="1"/>
          <p:nvPr/>
        </p:nvSpPr>
        <p:spPr>
          <a:xfrm rot="19189580">
            <a:off x="4072063" y="2366050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ge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62BB2C65-1C70-AF64-FAFB-ECF8E9EE9E34}"/>
              </a:ext>
            </a:extLst>
          </p:cNvPr>
          <p:cNvCxnSpPr>
            <a:cxnSpLocks/>
          </p:cNvCxnSpPr>
          <p:nvPr/>
        </p:nvCxnSpPr>
        <p:spPr>
          <a:xfrm>
            <a:off x="4486813" y="3251005"/>
            <a:ext cx="990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文本框 9">
            <a:extLst>
              <a:ext uri="{FF2B5EF4-FFF2-40B4-BE49-F238E27FC236}">
                <a16:creationId xmlns:a16="http://schemas.microsoft.com/office/drawing/2014/main" id="{F4AAB4B0-53B1-D112-9F8E-D2185EECDBA0}"/>
              </a:ext>
            </a:extLst>
          </p:cNvPr>
          <p:cNvSpPr txBox="1"/>
          <p:nvPr/>
        </p:nvSpPr>
        <p:spPr>
          <a:xfrm>
            <a:off x="4594080" y="3083951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70</a:t>
            </a:r>
            <a:endParaRPr lang="zh-CN" altLang="en-US" sz="1600" dirty="0"/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F7B2BD63-F966-7929-7B92-E846E3A7EEDA}"/>
              </a:ext>
            </a:extLst>
          </p:cNvPr>
          <p:cNvSpPr/>
          <p:nvPr/>
        </p:nvSpPr>
        <p:spPr>
          <a:xfrm>
            <a:off x="3382499" y="2935262"/>
            <a:ext cx="1059180" cy="4327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832825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AC19DE72-2AAB-DFEA-D0D6-8323FE0F2A8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3322">
            <a:off x="-1" y="0"/>
            <a:ext cx="8379229" cy="6858000"/>
          </a:xfrm>
          <a:prstGeom prst="rect">
            <a:avLst/>
          </a:prstGeom>
          <a:noFill/>
        </p:spPr>
      </p:pic>
      <p:sp>
        <p:nvSpPr>
          <p:cNvPr id="8" name="テキスト ボックス 1">
            <a:extLst>
              <a:ext uri="{FF2B5EF4-FFF2-40B4-BE49-F238E27FC236}">
                <a16:creationId xmlns:a16="http://schemas.microsoft.com/office/drawing/2014/main" id="{AEA50AA2-7586-80D0-394C-FCD1AF776268}"/>
              </a:ext>
            </a:extLst>
          </p:cNvPr>
          <p:cNvSpPr txBox="1"/>
          <p:nvPr/>
        </p:nvSpPr>
        <p:spPr>
          <a:xfrm>
            <a:off x="-138080" y="6335449"/>
            <a:ext cx="731438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The area enclosed by the red box was cropped and used in the Figure.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1315DC68-C5FC-D713-1F23-C4DCCC0532D3}"/>
              </a:ext>
            </a:extLst>
          </p:cNvPr>
          <p:cNvSpPr txBox="1"/>
          <p:nvPr/>
        </p:nvSpPr>
        <p:spPr>
          <a:xfrm rot="19189580">
            <a:off x="3517370" y="2261066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Youn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C5FBD518-2F68-CCD9-55FE-6B0070514CE4}"/>
              </a:ext>
            </a:extLst>
          </p:cNvPr>
          <p:cNvSpPr txBox="1"/>
          <p:nvPr/>
        </p:nvSpPr>
        <p:spPr>
          <a:xfrm rot="19189580">
            <a:off x="4072063" y="2295709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ge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6643FFBB-E72B-9746-5640-95E55835010C}"/>
              </a:ext>
            </a:extLst>
          </p:cNvPr>
          <p:cNvCxnSpPr>
            <a:cxnSpLocks/>
          </p:cNvCxnSpPr>
          <p:nvPr/>
        </p:nvCxnSpPr>
        <p:spPr>
          <a:xfrm>
            <a:off x="4770120" y="3695700"/>
            <a:ext cx="990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2386F1C9-4AA3-E2F2-C7FD-4EE13F7C3BC0}"/>
              </a:ext>
            </a:extLst>
          </p:cNvPr>
          <p:cNvSpPr txBox="1"/>
          <p:nvPr/>
        </p:nvSpPr>
        <p:spPr>
          <a:xfrm>
            <a:off x="246185" y="246185"/>
            <a:ext cx="10070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DDB1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19F36280-0F1F-D87D-29F6-AA33193DE271}"/>
              </a:ext>
            </a:extLst>
          </p:cNvPr>
          <p:cNvSpPr txBox="1"/>
          <p:nvPr/>
        </p:nvSpPr>
        <p:spPr>
          <a:xfrm>
            <a:off x="4877387" y="3528646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75</a:t>
            </a:r>
            <a:endParaRPr lang="zh-CN" altLang="en-US" sz="1600" dirty="0"/>
          </a:p>
        </p:txBody>
      </p: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B1F3BDC0-2925-816E-6D3B-565E52F89C66}"/>
              </a:ext>
            </a:extLst>
          </p:cNvPr>
          <p:cNvCxnSpPr>
            <a:cxnSpLocks/>
          </p:cNvCxnSpPr>
          <p:nvPr/>
        </p:nvCxnSpPr>
        <p:spPr>
          <a:xfrm>
            <a:off x="4770120" y="3406140"/>
            <a:ext cx="990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41DC0459-A9E5-26B2-C853-834D61175B52}"/>
              </a:ext>
            </a:extLst>
          </p:cNvPr>
          <p:cNvSpPr txBox="1"/>
          <p:nvPr/>
        </p:nvSpPr>
        <p:spPr>
          <a:xfrm>
            <a:off x="4877387" y="3239086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100</a:t>
            </a:r>
            <a:endParaRPr lang="zh-CN" altLang="en-US" sz="1600" dirty="0"/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F38E0174-81AC-9BD8-C13B-8FA2F18C7134}"/>
              </a:ext>
            </a:extLst>
          </p:cNvPr>
          <p:cNvCxnSpPr>
            <a:cxnSpLocks/>
          </p:cNvCxnSpPr>
          <p:nvPr/>
        </p:nvCxnSpPr>
        <p:spPr>
          <a:xfrm>
            <a:off x="4770120" y="3200400"/>
            <a:ext cx="990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42A5D1E0-1EDE-73FE-924A-A54025CB6E7F}"/>
              </a:ext>
            </a:extLst>
          </p:cNvPr>
          <p:cNvSpPr txBox="1"/>
          <p:nvPr/>
        </p:nvSpPr>
        <p:spPr>
          <a:xfrm>
            <a:off x="4877387" y="3033346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150</a:t>
            </a:r>
            <a:endParaRPr lang="zh-CN" altLang="en-US" sz="1600" dirty="0"/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E4C3586B-8DE2-4D3F-1F49-4AAD0BD94529}"/>
              </a:ext>
            </a:extLst>
          </p:cNvPr>
          <p:cNvCxnSpPr>
            <a:cxnSpLocks/>
          </p:cNvCxnSpPr>
          <p:nvPr/>
        </p:nvCxnSpPr>
        <p:spPr>
          <a:xfrm>
            <a:off x="4770120" y="2981960"/>
            <a:ext cx="990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59BA8037-6FC0-0B1E-672A-A491343CCCA3}"/>
              </a:ext>
            </a:extLst>
          </p:cNvPr>
          <p:cNvSpPr txBox="1"/>
          <p:nvPr/>
        </p:nvSpPr>
        <p:spPr>
          <a:xfrm>
            <a:off x="4877387" y="2814906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240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250</a:t>
            </a:r>
            <a:endParaRPr lang="zh-CN" altLang="en-US" sz="1600" dirty="0"/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0DF5CC6B-2202-788A-DF91-88A7AC66D3F8}"/>
              </a:ext>
            </a:extLst>
          </p:cNvPr>
          <p:cNvSpPr/>
          <p:nvPr/>
        </p:nvSpPr>
        <p:spPr>
          <a:xfrm>
            <a:off x="3388360" y="3056603"/>
            <a:ext cx="1336039" cy="4094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30375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57</TotalTime>
  <Words>103</Words>
  <Application>Microsoft Office PowerPoint</Application>
  <PresentationFormat>宽屏</PresentationFormat>
  <Paragraphs>33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9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an Rong</dc:creator>
  <cp:lastModifiedBy>yan Rong</cp:lastModifiedBy>
  <cp:revision>11</cp:revision>
  <dcterms:created xsi:type="dcterms:W3CDTF">2026-03-07T08:24:33Z</dcterms:created>
  <dcterms:modified xsi:type="dcterms:W3CDTF">2026-03-08T03:43:45Z</dcterms:modified>
</cp:coreProperties>
</file>